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png" ContentType="image/png"/>
  <Override PartName="/ppt/media/image3.png" ContentType="image/png"/>
  <Override PartName="/ppt/media/image4.png" ContentType="image/png"/>
  <Override PartName="/ppt/media/image5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902825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FBF7D2-C053-4102-B9A8-E6C5DD14593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95360" y="274320"/>
            <a:ext cx="8913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8913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5360" y="3964320"/>
            <a:ext cx="8913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F6AF0F-CD78-4CF7-864F-C9F137B12B2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95360" y="274320"/>
            <a:ext cx="8913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434952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62680" y="1600200"/>
            <a:ext cx="434952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95360" y="3964320"/>
            <a:ext cx="434952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62680" y="3964320"/>
            <a:ext cx="434952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56203F-1F5C-45A2-91F8-AE01872B5C3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95360" y="274320"/>
            <a:ext cx="8913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286992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09280" y="1600200"/>
            <a:ext cx="286992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522840" y="1600200"/>
            <a:ext cx="286992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95360" y="3964320"/>
            <a:ext cx="286992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09280" y="3964320"/>
            <a:ext cx="286992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522840" y="3964320"/>
            <a:ext cx="286992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EA8C26-A097-4620-8887-FF74E115367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95360" y="274320"/>
            <a:ext cx="8913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95360" y="1600200"/>
            <a:ext cx="8913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DF1A39-0483-4A51-8DF5-36B3B506183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95360" y="274320"/>
            <a:ext cx="8913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8913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5CEA76-B52A-4EB5-8A08-F762134B789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95360" y="274320"/>
            <a:ext cx="8913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434952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62680" y="1600200"/>
            <a:ext cx="434952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FB1179-DBCF-4B21-B0C2-E206B08CA7F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5360" y="274320"/>
            <a:ext cx="8913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9D9319-B8E4-4528-91A9-BABA9FF8850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95360" y="274320"/>
            <a:ext cx="8913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A8663A-4C8B-42A6-9187-4834A959B19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95360" y="274320"/>
            <a:ext cx="8913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434952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62680" y="1600200"/>
            <a:ext cx="434952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95360" y="3964320"/>
            <a:ext cx="434952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4A0E5C-D579-4FB3-9D4E-2EE1C4992CB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95360" y="274320"/>
            <a:ext cx="8913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434952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62680" y="1600200"/>
            <a:ext cx="434952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62680" y="3964320"/>
            <a:ext cx="434952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F2B8B6-CDD2-4D38-9442-5532F12A9D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95360" y="274320"/>
            <a:ext cx="8913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434952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62680" y="1600200"/>
            <a:ext cx="434952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95360" y="3964320"/>
            <a:ext cx="8913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415EAD-893F-4B5E-81F3-042B117ED3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95360" y="274320"/>
            <a:ext cx="8913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95360" y="1600200"/>
            <a:ext cx="8913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5360" y="6244920"/>
            <a:ext cx="231120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382920" y="6244920"/>
            <a:ext cx="31370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097760" y="6244920"/>
            <a:ext cx="2311200" cy="4762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7965527-9124-4E86-9962-981F7035D5E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1065240" y="2130120"/>
            <a:ext cx="7772400" cy="1469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Full uncropped gel/blot imag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"/>
          <p:cNvSpPr txBox="1"/>
          <p:nvPr/>
        </p:nvSpPr>
        <p:spPr>
          <a:xfrm>
            <a:off x="2142720" y="5949720"/>
            <a:ext cx="6413400" cy="5331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1280" indent="-341280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Source data for Western blots presented in Figure 2.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" name="组合 2"/>
          <p:cNvGrpSpPr/>
          <p:nvPr/>
        </p:nvGrpSpPr>
        <p:grpSpPr>
          <a:xfrm>
            <a:off x="4519440" y="117360"/>
            <a:ext cx="3384720" cy="2519640"/>
            <a:chOff x="4519440" y="117360"/>
            <a:chExt cx="3384720" cy="2519640"/>
          </a:xfrm>
        </p:grpSpPr>
        <p:pic>
          <p:nvPicPr>
            <p:cNvPr id="44" name="图片 2" descr="20241009_CRT_merge"/>
            <p:cNvPicPr/>
            <p:nvPr/>
          </p:nvPicPr>
          <p:blipFill>
            <a:blip r:embed="rId1"/>
            <a:srcRect l="27065" t="32630" r="31936" b="36866"/>
            <a:stretch/>
          </p:blipFill>
          <p:spPr>
            <a:xfrm>
              <a:off x="4519440" y="117360"/>
              <a:ext cx="3384720" cy="2519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5" name="文本框 5"/>
            <p:cNvSpPr/>
            <p:nvPr/>
          </p:nvSpPr>
          <p:spPr>
            <a:xfrm>
              <a:off x="5883480" y="432000"/>
              <a:ext cx="655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CR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6" name="组合 3"/>
          <p:cNvGrpSpPr/>
          <p:nvPr/>
        </p:nvGrpSpPr>
        <p:grpSpPr>
          <a:xfrm>
            <a:off x="847800" y="2924280"/>
            <a:ext cx="3217680" cy="2711520"/>
            <a:chOff x="847800" y="2924280"/>
            <a:chExt cx="3217680" cy="2711520"/>
          </a:xfrm>
        </p:grpSpPr>
        <p:pic>
          <p:nvPicPr>
            <p:cNvPr id="47" name="图片 3" descr="20241008_gapdh_merge"/>
            <p:cNvPicPr/>
            <p:nvPr/>
          </p:nvPicPr>
          <p:blipFill>
            <a:blip r:embed="rId2"/>
            <a:srcRect l="21628" t="25004" r="33883" b="37663"/>
            <a:stretch/>
          </p:blipFill>
          <p:spPr>
            <a:xfrm>
              <a:off x="847800" y="2924280"/>
              <a:ext cx="3217680" cy="2711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8" name="文本框 6"/>
            <p:cNvSpPr/>
            <p:nvPr/>
          </p:nvSpPr>
          <p:spPr>
            <a:xfrm>
              <a:off x="2106360" y="3428640"/>
              <a:ext cx="887760" cy="334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GAPDH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9" name="组合 5"/>
          <p:cNvGrpSpPr/>
          <p:nvPr/>
        </p:nvGrpSpPr>
        <p:grpSpPr>
          <a:xfrm>
            <a:off x="774720" y="44280"/>
            <a:ext cx="3384360" cy="2654640"/>
            <a:chOff x="774720" y="44280"/>
            <a:chExt cx="3384360" cy="2654640"/>
          </a:xfrm>
        </p:grpSpPr>
        <p:pic>
          <p:nvPicPr>
            <p:cNvPr id="50" name="图片 1" descr="20241007_pcca_merge(1)"/>
            <p:cNvPicPr/>
            <p:nvPr/>
          </p:nvPicPr>
          <p:blipFill>
            <a:blip r:embed="rId3"/>
            <a:srcRect l="27865" t="16531" r="22933" b="44956"/>
            <a:stretch/>
          </p:blipFill>
          <p:spPr>
            <a:xfrm>
              <a:off x="774720" y="44280"/>
              <a:ext cx="3384360" cy="2654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1" name="文本框 5"/>
            <p:cNvSpPr/>
            <p:nvPr/>
          </p:nvSpPr>
          <p:spPr>
            <a:xfrm>
              <a:off x="2282760" y="526680"/>
              <a:ext cx="575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PCC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2" name="组合 1"/>
          <p:cNvGrpSpPr/>
          <p:nvPr/>
        </p:nvGrpSpPr>
        <p:grpSpPr>
          <a:xfrm>
            <a:off x="1422360" y="4940280"/>
            <a:ext cx="2563920" cy="260280"/>
            <a:chOff x="1422360" y="4940280"/>
            <a:chExt cx="2563920" cy="260280"/>
          </a:xfrm>
        </p:grpSpPr>
        <p:sp>
          <p:nvSpPr>
            <p:cNvPr id="53" name="文本框 13"/>
            <p:cNvSpPr/>
            <p:nvPr/>
          </p:nvSpPr>
          <p:spPr>
            <a:xfrm>
              <a:off x="1814760" y="4940280"/>
              <a:ext cx="612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Mut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文本框 14"/>
            <p:cNvSpPr/>
            <p:nvPr/>
          </p:nvSpPr>
          <p:spPr>
            <a:xfrm>
              <a:off x="1422360" y="4940280"/>
              <a:ext cx="617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WT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文本框 13"/>
            <p:cNvSpPr/>
            <p:nvPr/>
          </p:nvSpPr>
          <p:spPr>
            <a:xfrm>
              <a:off x="2595960" y="4940280"/>
              <a:ext cx="61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Mut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文本框 14"/>
            <p:cNvSpPr/>
            <p:nvPr/>
          </p:nvSpPr>
          <p:spPr>
            <a:xfrm>
              <a:off x="2202120" y="4940280"/>
              <a:ext cx="617040" cy="260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WT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文本框 13"/>
            <p:cNvSpPr/>
            <p:nvPr/>
          </p:nvSpPr>
          <p:spPr>
            <a:xfrm>
              <a:off x="3375360" y="4940280"/>
              <a:ext cx="61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Mut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文本框 14"/>
            <p:cNvSpPr/>
            <p:nvPr/>
          </p:nvSpPr>
          <p:spPr>
            <a:xfrm>
              <a:off x="2983320" y="4940280"/>
              <a:ext cx="615960" cy="260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WT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9" name="组合 6"/>
          <p:cNvGrpSpPr/>
          <p:nvPr/>
        </p:nvGrpSpPr>
        <p:grpSpPr>
          <a:xfrm>
            <a:off x="1135080" y="1971720"/>
            <a:ext cx="2563920" cy="258840"/>
            <a:chOff x="1135080" y="1971720"/>
            <a:chExt cx="2563920" cy="258840"/>
          </a:xfrm>
        </p:grpSpPr>
        <p:sp>
          <p:nvSpPr>
            <p:cNvPr id="60" name="文本框 13"/>
            <p:cNvSpPr/>
            <p:nvPr/>
          </p:nvSpPr>
          <p:spPr>
            <a:xfrm>
              <a:off x="1526760" y="1971720"/>
              <a:ext cx="612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Mut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文本框 14"/>
            <p:cNvSpPr/>
            <p:nvPr/>
          </p:nvSpPr>
          <p:spPr>
            <a:xfrm>
              <a:off x="1135080" y="1971720"/>
              <a:ext cx="617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WT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文本框 13"/>
            <p:cNvSpPr/>
            <p:nvPr/>
          </p:nvSpPr>
          <p:spPr>
            <a:xfrm>
              <a:off x="2307960" y="1971720"/>
              <a:ext cx="611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Mut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文本框 14"/>
            <p:cNvSpPr/>
            <p:nvPr/>
          </p:nvSpPr>
          <p:spPr>
            <a:xfrm>
              <a:off x="1914120" y="1971720"/>
              <a:ext cx="617760" cy="258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WT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文本框 13"/>
            <p:cNvSpPr/>
            <p:nvPr/>
          </p:nvSpPr>
          <p:spPr>
            <a:xfrm>
              <a:off x="3088080" y="1971720"/>
              <a:ext cx="61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Mut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文本框 14"/>
            <p:cNvSpPr/>
            <p:nvPr/>
          </p:nvSpPr>
          <p:spPr>
            <a:xfrm>
              <a:off x="2695680" y="1971720"/>
              <a:ext cx="615960" cy="258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WT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6" name="组合 13"/>
          <p:cNvGrpSpPr/>
          <p:nvPr/>
        </p:nvGrpSpPr>
        <p:grpSpPr>
          <a:xfrm>
            <a:off x="5022720" y="1773360"/>
            <a:ext cx="2563920" cy="258480"/>
            <a:chOff x="5022720" y="1773360"/>
            <a:chExt cx="2563920" cy="258480"/>
          </a:xfrm>
        </p:grpSpPr>
        <p:sp>
          <p:nvSpPr>
            <p:cNvPr id="67" name="文本框 13"/>
            <p:cNvSpPr/>
            <p:nvPr/>
          </p:nvSpPr>
          <p:spPr>
            <a:xfrm>
              <a:off x="5414400" y="1773360"/>
              <a:ext cx="612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Mut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文本框 14"/>
            <p:cNvSpPr/>
            <p:nvPr/>
          </p:nvSpPr>
          <p:spPr>
            <a:xfrm>
              <a:off x="5022720" y="1773360"/>
              <a:ext cx="617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WT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文本框 13"/>
            <p:cNvSpPr/>
            <p:nvPr/>
          </p:nvSpPr>
          <p:spPr>
            <a:xfrm>
              <a:off x="6195600" y="1773360"/>
              <a:ext cx="611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Mut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文本框 14"/>
            <p:cNvSpPr/>
            <p:nvPr/>
          </p:nvSpPr>
          <p:spPr>
            <a:xfrm>
              <a:off x="5801760" y="1773360"/>
              <a:ext cx="617760" cy="258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WT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文本框 13"/>
            <p:cNvSpPr/>
            <p:nvPr/>
          </p:nvSpPr>
          <p:spPr>
            <a:xfrm>
              <a:off x="6975720" y="1773360"/>
              <a:ext cx="61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Mut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文本框 14"/>
            <p:cNvSpPr/>
            <p:nvPr/>
          </p:nvSpPr>
          <p:spPr>
            <a:xfrm>
              <a:off x="6583320" y="1773360"/>
              <a:ext cx="615960" cy="258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WT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文本框 2"/>
          <p:cNvSpPr/>
          <p:nvPr/>
        </p:nvSpPr>
        <p:spPr>
          <a:xfrm>
            <a:off x="631800" y="3789360"/>
            <a:ext cx="8928000" cy="1752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Full uncropped gel/blot membranes corresponding to Figure 3.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a, Coomassie Brilliant Blue staining of the total protein gel, used as a loading control. b, Immunoblot for total protein propionylation levels using an anti-propionyllysine antibody. Molecular weight markers (in kDa) are indicated on the left of each image.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文本框 2"/>
          <p:cNvSpPr/>
          <p:nvPr/>
        </p:nvSpPr>
        <p:spPr>
          <a:xfrm>
            <a:off x="2719440" y="547560"/>
            <a:ext cx="431640" cy="53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文本框 3"/>
          <p:cNvSpPr/>
          <p:nvPr/>
        </p:nvSpPr>
        <p:spPr>
          <a:xfrm>
            <a:off x="6014880" y="474840"/>
            <a:ext cx="433440" cy="53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6" name="组合 4"/>
          <p:cNvGrpSpPr/>
          <p:nvPr/>
        </p:nvGrpSpPr>
        <p:grpSpPr>
          <a:xfrm>
            <a:off x="2054520" y="907920"/>
            <a:ext cx="1601640" cy="2553120"/>
            <a:chOff x="2054520" y="907920"/>
            <a:chExt cx="1601640" cy="2553120"/>
          </a:xfrm>
        </p:grpSpPr>
        <p:pic>
          <p:nvPicPr>
            <p:cNvPr id="77" name="图片 5" descr="2024-11-02_14-57-29_1_16bit"/>
            <p:cNvPicPr/>
            <p:nvPr/>
          </p:nvPicPr>
          <p:blipFill>
            <a:blip r:embed="rId1"/>
            <a:srcRect l="31123" t="37465" r="41230" b="18417"/>
            <a:stretch/>
          </p:blipFill>
          <p:spPr>
            <a:xfrm>
              <a:off x="2216160" y="907920"/>
              <a:ext cx="1440000" cy="1728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8" name="文本框 8"/>
            <p:cNvSpPr/>
            <p:nvPr/>
          </p:nvSpPr>
          <p:spPr>
            <a:xfrm rot="18780000">
              <a:off x="1973160" y="2870280"/>
              <a:ext cx="1038240" cy="229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WT+Pro 3m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文本框 9"/>
            <p:cNvSpPr/>
            <p:nvPr/>
          </p:nvSpPr>
          <p:spPr>
            <a:xfrm rot="18780000">
              <a:off x="2646720" y="2718720"/>
              <a:ext cx="576360" cy="230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Mu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文本框 10"/>
            <p:cNvSpPr/>
            <p:nvPr/>
          </p:nvSpPr>
          <p:spPr>
            <a:xfrm rot="18780000">
              <a:off x="2057040" y="2702520"/>
              <a:ext cx="580680" cy="230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W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文本框 11"/>
            <p:cNvSpPr/>
            <p:nvPr/>
          </p:nvSpPr>
          <p:spPr>
            <a:xfrm rot="18780000">
              <a:off x="2517840" y="2886480"/>
              <a:ext cx="1038240" cy="231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Mut+Pro 3m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2" name="组合 5"/>
          <p:cNvGrpSpPr/>
          <p:nvPr/>
        </p:nvGrpSpPr>
        <p:grpSpPr>
          <a:xfrm>
            <a:off x="5424480" y="746280"/>
            <a:ext cx="1593720" cy="2660400"/>
            <a:chOff x="5424480" y="746280"/>
            <a:chExt cx="1593720" cy="2660400"/>
          </a:xfrm>
        </p:grpSpPr>
        <p:pic>
          <p:nvPicPr>
            <p:cNvPr id="83" name="图片 2" descr="丙酰化"/>
            <p:cNvPicPr/>
            <p:nvPr/>
          </p:nvPicPr>
          <p:blipFill>
            <a:blip r:embed="rId2"/>
            <a:srcRect l="-1085" t="-1150" r="-2911" b="-5019"/>
            <a:stretch/>
          </p:blipFill>
          <p:spPr>
            <a:xfrm>
              <a:off x="5424480" y="746280"/>
              <a:ext cx="1593720" cy="1970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4" name="文本框 10"/>
            <p:cNvSpPr/>
            <p:nvPr/>
          </p:nvSpPr>
          <p:spPr>
            <a:xfrm rot="18780000">
              <a:off x="5508720" y="2668320"/>
              <a:ext cx="582480" cy="229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W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文本框 8"/>
            <p:cNvSpPr/>
            <p:nvPr/>
          </p:nvSpPr>
          <p:spPr>
            <a:xfrm rot="18780000">
              <a:off x="5488560" y="2827080"/>
              <a:ext cx="1037880" cy="231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WT+Pro 3m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文本框 9"/>
            <p:cNvSpPr/>
            <p:nvPr/>
          </p:nvSpPr>
          <p:spPr>
            <a:xfrm rot="18780000">
              <a:off x="6074640" y="2667240"/>
              <a:ext cx="577440" cy="228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Mu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文本框 11"/>
            <p:cNvSpPr/>
            <p:nvPr/>
          </p:nvSpPr>
          <p:spPr>
            <a:xfrm rot="18780000">
              <a:off x="5947200" y="2835000"/>
              <a:ext cx="1037880" cy="228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Mut+Pro 3m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4-12-19T03:03:46Z</dcterms:created>
  <dc:creator>Lenovo</dc:creator>
  <dc:description/>
  <dc:language>en-US</dc:language>
  <cp:lastModifiedBy>王友</cp:lastModifiedBy>
  <dcterms:modified xsi:type="dcterms:W3CDTF">2025-12-20T00:57:39Z</dcterms:modified>
  <cp:revision>55</cp:revision>
  <dc:subject/>
  <dc:title>RESULT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60F51B3806FE43CD8404D8DF64174C0C_12</vt:lpwstr>
  </property>
  <property fmtid="{D5CDD505-2E9C-101B-9397-08002B2CF9AE}" pid="3" name="KSOProductBuildVer">
    <vt:lpwstr>2052-12.1.0.24034</vt:lpwstr>
  </property>
</Properties>
</file>